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84" r:id="rId3"/>
    <p:sldId id="276" r:id="rId4"/>
    <p:sldId id="285" r:id="rId5"/>
    <p:sldId id="286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456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김규봉" userId="7090dd21-cfab-47af-aa8e-a551adfff755" providerId="ADAL" clId="{78441724-E7EE-4864-9967-AC93509C4AF1}"/>
    <pc:docChg chg="modSld">
      <pc:chgData name="김규봉" userId="7090dd21-cfab-47af-aa8e-a551adfff755" providerId="ADAL" clId="{78441724-E7EE-4864-9967-AC93509C4AF1}" dt="2022-05-27T14:57:02.200" v="5" actId="255"/>
      <pc:docMkLst>
        <pc:docMk/>
      </pc:docMkLst>
      <pc:sldChg chg="modSp">
        <pc:chgData name="김규봉" userId="7090dd21-cfab-47af-aa8e-a551adfff755" providerId="ADAL" clId="{78441724-E7EE-4864-9967-AC93509C4AF1}" dt="2022-05-27T14:56:35.683" v="1" actId="255"/>
        <pc:sldMkLst>
          <pc:docMk/>
          <pc:sldMk cId="4051619150" sldId="275"/>
        </pc:sldMkLst>
        <pc:spChg chg="mod">
          <ac:chgData name="김규봉" userId="7090dd21-cfab-47af-aa8e-a551adfff755" providerId="ADAL" clId="{78441724-E7EE-4864-9967-AC93509C4AF1}" dt="2022-05-27T14:56:35.683" v="1" actId="255"/>
          <ac:spMkLst>
            <pc:docMk/>
            <pc:sldMk cId="4051619150" sldId="275"/>
            <ac:spMk id="14" creationId="{8EFF375E-99BA-4A3C-8969-3FE3C31D7DBF}"/>
          </ac:spMkLst>
        </pc:spChg>
      </pc:sldChg>
      <pc:sldChg chg="modSp">
        <pc:chgData name="김규봉" userId="7090dd21-cfab-47af-aa8e-a551adfff755" providerId="ADAL" clId="{78441724-E7EE-4864-9967-AC93509C4AF1}" dt="2022-05-27T14:56:49.034" v="3" actId="255"/>
        <pc:sldMkLst>
          <pc:docMk/>
          <pc:sldMk cId="2758525102" sldId="276"/>
        </pc:sldMkLst>
        <pc:spChg chg="mod">
          <ac:chgData name="김규봉" userId="7090dd21-cfab-47af-aa8e-a551adfff755" providerId="ADAL" clId="{78441724-E7EE-4864-9967-AC93509C4AF1}" dt="2022-05-27T14:56:49.034" v="3" actId="255"/>
          <ac:spMkLst>
            <pc:docMk/>
            <pc:sldMk cId="2758525102" sldId="276"/>
            <ac:spMk id="10" creationId="{D707EC51-231F-4D40-9B88-1DE3E3A57A0B}"/>
          </ac:spMkLst>
        </pc:spChg>
      </pc:sldChg>
      <pc:sldChg chg="modSp">
        <pc:chgData name="김규봉" userId="7090dd21-cfab-47af-aa8e-a551adfff755" providerId="ADAL" clId="{78441724-E7EE-4864-9967-AC93509C4AF1}" dt="2022-05-27T14:56:43.721" v="2" actId="255"/>
        <pc:sldMkLst>
          <pc:docMk/>
          <pc:sldMk cId="2067262294" sldId="284"/>
        </pc:sldMkLst>
        <pc:spChg chg="mod">
          <ac:chgData name="김규봉" userId="7090dd21-cfab-47af-aa8e-a551adfff755" providerId="ADAL" clId="{78441724-E7EE-4864-9967-AC93509C4AF1}" dt="2022-05-27T14:56:43.721" v="2" actId="255"/>
          <ac:spMkLst>
            <pc:docMk/>
            <pc:sldMk cId="2067262294" sldId="284"/>
            <ac:spMk id="14" creationId="{8EFF375E-99BA-4A3C-8969-3FE3C31D7DBF}"/>
          </ac:spMkLst>
        </pc:spChg>
      </pc:sldChg>
      <pc:sldChg chg="modSp">
        <pc:chgData name="김규봉" userId="7090dd21-cfab-47af-aa8e-a551adfff755" providerId="ADAL" clId="{78441724-E7EE-4864-9967-AC93509C4AF1}" dt="2022-05-27T14:56:56.754" v="4" actId="255"/>
        <pc:sldMkLst>
          <pc:docMk/>
          <pc:sldMk cId="1830873630" sldId="285"/>
        </pc:sldMkLst>
        <pc:spChg chg="mod">
          <ac:chgData name="김규봉" userId="7090dd21-cfab-47af-aa8e-a551adfff755" providerId="ADAL" clId="{78441724-E7EE-4864-9967-AC93509C4AF1}" dt="2022-05-27T14:56:56.754" v="4" actId="255"/>
          <ac:spMkLst>
            <pc:docMk/>
            <pc:sldMk cId="1830873630" sldId="285"/>
            <ac:spMk id="21" creationId="{BCFD3056-159B-78D9-ED57-CDF704662037}"/>
          </ac:spMkLst>
        </pc:spChg>
      </pc:sldChg>
      <pc:sldChg chg="modSp">
        <pc:chgData name="김규봉" userId="7090dd21-cfab-47af-aa8e-a551adfff755" providerId="ADAL" clId="{78441724-E7EE-4864-9967-AC93509C4AF1}" dt="2022-05-27T14:57:02.200" v="5" actId="255"/>
        <pc:sldMkLst>
          <pc:docMk/>
          <pc:sldMk cId="4031756193" sldId="286"/>
        </pc:sldMkLst>
        <pc:spChg chg="mod">
          <ac:chgData name="김규봉" userId="7090dd21-cfab-47af-aa8e-a551adfff755" providerId="ADAL" clId="{78441724-E7EE-4864-9967-AC93509C4AF1}" dt="2022-05-27T14:57:02.200" v="5" actId="255"/>
          <ac:spMkLst>
            <pc:docMk/>
            <pc:sldMk cId="4031756193" sldId="286"/>
            <ac:spMk id="21" creationId="{BCFD3056-159B-78D9-ED57-CDF70466203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9271B1C-E230-4877-A08E-A7D01617A2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1EF27C8-1779-4A10-90FE-D868026D51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E4C184A-0FE2-4FCF-9758-CA819CAB2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889FC9F-3EB0-461D-9DF5-6D06F07CD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57B5934-CB54-4A4E-949E-F04F1B026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2357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F16BD28-A498-4378-A988-1A2CCC37B3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57D4DF3-65E0-4EAF-8CA8-5BE25723C9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84BA2C4-C9ED-4E83-A746-E1FDC2B86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5838066-9D2D-4135-801B-B6AFCF642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5FCC9C2-7ABF-4995-A6A9-35CF445F2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1079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2B9E1A21-A25E-4621-B8F4-C79EDEAFE5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924847A-8F99-49FF-8EC8-8A1D992E8E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76206BC-977E-4095-8E0A-2C3118259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5F1A8DA-5DA4-40FF-84B1-BAF50DF3B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660A6A8-A50A-4FDA-92AB-0589C6E54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6184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423A962-630D-4DB3-A690-934239E620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1615206-7B53-4ED6-BB86-150FD55141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07871F1-A105-4770-BE28-5E6B4E1C4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2FCCB2F-09F1-4202-87A1-EF6BDF584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BA86E5-3FD4-40D9-8BD6-5E2E28F10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0420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8DDBE09-8784-423F-8D20-5DAD645557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531854D-2ACE-4378-A1BC-87865F3A05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AE09C1-77C6-4D78-9F97-0A1B93EFF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9DF6DAE-576B-4500-867E-21AB7340E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99F331A-E7C5-4978-8467-174AB11FA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1283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48EF69D-3F28-40C1-A872-935A6998E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6B9D78-8641-429C-8414-F0058E846A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10A237E-9054-4476-BB79-B1E2F001AB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BF237D3-2091-436A-85BB-D887D52B1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D36B293-C142-415B-9AB0-390CC2C2B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EE01A2D-7526-4AC0-80BB-8EBB1C542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8243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0CF3D36-496A-4F8E-ADA9-2A346F795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E29ECAA-31FB-4C1A-8068-A6423404E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B8B3492-7FE8-4130-B424-0170DD9CDC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8386B395-6851-4494-8F98-055AB0DEF3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0F2B825-F6BC-4CD5-99D7-0D0F65F2D1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5C4C00C-4E75-4CBB-B027-B41B39865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B83D272-8533-4BDB-92B0-A1E6FFC4D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BEA5F10-B106-476A-B004-F4C1CB1FA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8815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C4F73DC-BDBE-415D-8E79-886F66CAA2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8F3564C-826D-42A7-8432-768D22763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7DAB13A-056E-423A-84CD-B951E33E4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B393833-3F8B-4997-A869-89AE11BE2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3675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8DE42FF-3E41-432A-A581-5A2DE51CD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6B8E2F9-952D-483B-8991-570E7E647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F1B4026-DB7F-4B86-9C7B-0BA86F07F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1557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9E0D44D-33D1-499F-B794-98B456CE0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21F3657-0C7A-496E-8F57-64B3DD3E4B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65430F3-37C4-45A1-AD15-98DD55076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E75222B-D5E2-4E13-9604-2F4E81326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D4238F1-7A90-4E6F-9F72-73D841045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0D0E56E-D4A0-4D30-9986-9861147AB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5781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A8B6BD1-05BB-415D-B999-EE4664D489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B1B573B-61A0-4EE7-8C35-32BDF8C05D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EE9CF30-208C-4501-86D3-20D1986500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42BC0DF-4B16-4EB1-BB11-15401FF68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8AF3870-D644-4EDF-BAA6-CC397F9B8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53E2143-35CC-4291-A305-D359887C4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2985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8835367-3297-4780-94B1-63D78C1CF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100AC44-F0AC-416D-93A0-AE40B7A2F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05FB627-4FB2-477A-9AD0-C6B3167EAB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B85E4-7122-45A8-8663-648222F73B0B}" type="datetimeFigureOut">
              <a:rPr lang="ko-KR" altLang="en-US" smtClean="0"/>
              <a:t>2022-05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744C8F9-C403-490E-BDA6-47760E849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A83206F-250B-41FB-9FBA-BED07C3442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D1B18-CAA8-46DA-A19E-98E9D6A6EF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55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8EFF375E-99BA-4A3C-8969-3FE3C31D7DBF}"/>
              </a:ext>
            </a:extLst>
          </p:cNvPr>
          <p:cNvSpPr txBox="1"/>
          <p:nvPr/>
        </p:nvSpPr>
        <p:spPr>
          <a:xfrm>
            <a:off x="3185228" y="5398153"/>
            <a:ext cx="8463242" cy="33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Custom-designed acrylic chamber (39.5×37.5×42 cm).</a:t>
            </a:r>
            <a:endParaRPr lang="ko-KR" altLang="en-US" sz="1200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C3A1F1BC-12E9-49C6-92C9-2E18A56166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79" r="18170"/>
          <a:stretch/>
        </p:blipFill>
        <p:spPr>
          <a:xfrm rot="5400000">
            <a:off x="3599329" y="559228"/>
            <a:ext cx="4509247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16191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7AEBCF79-C86E-4A4F-9CD9-B6AD80BC73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92"/>
          <a:stretch/>
        </p:blipFill>
        <p:spPr>
          <a:xfrm>
            <a:off x="5747443" y="905689"/>
            <a:ext cx="4610108" cy="3979817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D274B928-3B7A-44BA-8361-602767B6A7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32"/>
          <a:stretch/>
        </p:blipFill>
        <p:spPr>
          <a:xfrm>
            <a:off x="1894309" y="1079862"/>
            <a:ext cx="3960386" cy="380564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EFF375E-99BA-4A3C-8969-3FE3C31D7DBF}"/>
              </a:ext>
            </a:extLst>
          </p:cNvPr>
          <p:cNvSpPr txBox="1"/>
          <p:nvPr/>
        </p:nvSpPr>
        <p:spPr>
          <a:xfrm>
            <a:off x="1894310" y="5059679"/>
            <a:ext cx="8463242" cy="1166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 comparison of serum binning patterns using </a:t>
            </a:r>
            <a:r>
              <a:rPr lang="en-US" altLang="ko-KR" sz="1200" b="1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-NMR spectroscopy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incipal component analysis (PCA) (R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X = 0.893, Q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= 0.622) (A) and orthogonal projections to latent structures-discriminant analysis (OPLS-DA) (R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X = 0.741, Q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= 0.0557) models results after NMR analysis of control, positive control and administered with sulforaphane after second-hand smoke exposure group in serum samples (B). (n=5); ▲, control (CON); </a:t>
            </a:r>
            <a:r>
              <a:rPr lang="en-US" altLang="ko-KR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positive control (PC); </a:t>
            </a:r>
            <a:r>
              <a:rPr lang="en-US" altLang="ko-KR" sz="1200" kern="100" dirty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test  (SS).</a:t>
            </a:r>
            <a:endParaRPr lang="ko-KR" altLang="en-US" sz="12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06B2D2A-925A-4C34-94CF-7B4190ED6F98}"/>
              </a:ext>
            </a:extLst>
          </p:cNvPr>
          <p:cNvSpPr txBox="1"/>
          <p:nvPr/>
        </p:nvSpPr>
        <p:spPr>
          <a:xfrm>
            <a:off x="1894309" y="905689"/>
            <a:ext cx="448384" cy="3300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(A)</a:t>
            </a:r>
            <a:endParaRPr lang="ko-KR" altLang="en-US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C14BD6-E400-4EC1-9F85-B9EB01C9AB54}"/>
              </a:ext>
            </a:extLst>
          </p:cNvPr>
          <p:cNvSpPr txBox="1"/>
          <p:nvPr/>
        </p:nvSpPr>
        <p:spPr>
          <a:xfrm>
            <a:off x="5854695" y="849083"/>
            <a:ext cx="448384" cy="3300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(B)</a:t>
            </a:r>
            <a:endParaRPr lang="ko-KR" altLang="en-US" b="1" dirty="0"/>
          </a:p>
        </p:txBody>
      </p:sp>
      <p:sp>
        <p:nvSpPr>
          <p:cNvPr id="21" name="타원 20">
            <a:extLst>
              <a:ext uri="{FF2B5EF4-FFF2-40B4-BE49-F238E27FC236}">
                <a16:creationId xmlns:a16="http://schemas.microsoft.com/office/drawing/2014/main" id="{C7985B71-CAEC-4688-90CD-A601218CE34E}"/>
              </a:ext>
            </a:extLst>
          </p:cNvPr>
          <p:cNvSpPr/>
          <p:nvPr/>
        </p:nvSpPr>
        <p:spPr>
          <a:xfrm rot="11355524">
            <a:off x="7387608" y="2809072"/>
            <a:ext cx="453008" cy="695570"/>
          </a:xfrm>
          <a:prstGeom prst="ellipse">
            <a:avLst/>
          </a:prstGeom>
          <a:noFill/>
          <a:ln w="28575"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타원 21">
            <a:extLst>
              <a:ext uri="{FF2B5EF4-FFF2-40B4-BE49-F238E27FC236}">
                <a16:creationId xmlns:a16="http://schemas.microsoft.com/office/drawing/2014/main" id="{9A49689E-85DF-43EF-8EA5-0CDB71B242B4}"/>
              </a:ext>
            </a:extLst>
          </p:cNvPr>
          <p:cNvSpPr/>
          <p:nvPr/>
        </p:nvSpPr>
        <p:spPr>
          <a:xfrm rot="18640274">
            <a:off x="8079813" y="2577214"/>
            <a:ext cx="683124" cy="804656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타원 22">
            <a:extLst>
              <a:ext uri="{FF2B5EF4-FFF2-40B4-BE49-F238E27FC236}">
                <a16:creationId xmlns:a16="http://schemas.microsoft.com/office/drawing/2014/main" id="{5F4E3903-54E8-4BD4-BF9D-5C5EA7959E4A}"/>
              </a:ext>
            </a:extLst>
          </p:cNvPr>
          <p:cNvSpPr/>
          <p:nvPr/>
        </p:nvSpPr>
        <p:spPr>
          <a:xfrm rot="12290120">
            <a:off x="7473878" y="2373403"/>
            <a:ext cx="733552" cy="477302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72622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33BB2D12-19ED-4F61-9092-6B0679EEB7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78"/>
          <a:stretch/>
        </p:blipFill>
        <p:spPr>
          <a:xfrm>
            <a:off x="2176773" y="731520"/>
            <a:ext cx="3878408" cy="3658447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2D301EFE-D6C3-447D-974E-76F781812C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78"/>
          <a:stretch/>
        </p:blipFill>
        <p:spPr>
          <a:xfrm>
            <a:off x="6055181" y="731518"/>
            <a:ext cx="4519410" cy="365844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707EC51-231F-4D40-9B88-1DE3E3A57A0B}"/>
              </a:ext>
            </a:extLst>
          </p:cNvPr>
          <p:cNvSpPr txBox="1"/>
          <p:nvPr/>
        </p:nvSpPr>
        <p:spPr>
          <a:xfrm>
            <a:off x="1981395" y="4695751"/>
            <a:ext cx="8463242" cy="1166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 comparison of lung binning patterns using </a:t>
            </a:r>
            <a:r>
              <a:rPr lang="en-US" altLang="ko-KR" sz="1200" b="1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-NMR spectroscopy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incipal component analysis (PCA) (R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X = 0.957, Q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= 0.819) (A) and orthogonal projections to latent structures-discriminant analysis (OPLS-DA) (R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X = 0.925, Q</a:t>
            </a:r>
            <a:r>
              <a:rPr lang="en-US" altLang="ko-KR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= -0.297) models results after NMR analysis of control, positive control and administered with sulforaphane after second-hand smoke exposure group in serum samples (B). (n=5); ▲, control (CON); </a:t>
            </a:r>
            <a:r>
              <a:rPr lang="en-US" altLang="ko-KR" sz="12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positive control (PC); </a:t>
            </a:r>
            <a:r>
              <a:rPr lang="en-US" altLang="ko-KR" sz="1200" kern="100" dirty="0"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▲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test  (SS).</a:t>
            </a:r>
            <a:endParaRPr lang="ko-KR" alt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201AC7-E53D-4576-9269-E8ED293BA7F3}"/>
              </a:ext>
            </a:extLst>
          </p:cNvPr>
          <p:cNvSpPr txBox="1"/>
          <p:nvPr/>
        </p:nvSpPr>
        <p:spPr>
          <a:xfrm>
            <a:off x="1807222" y="931816"/>
            <a:ext cx="448384" cy="3300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(A)</a:t>
            </a:r>
            <a:endParaRPr lang="ko-KR" altLang="en-US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7B6BA2-3F30-4CF4-A759-941D1AD3FB3E}"/>
              </a:ext>
            </a:extLst>
          </p:cNvPr>
          <p:cNvSpPr txBox="1"/>
          <p:nvPr/>
        </p:nvSpPr>
        <p:spPr>
          <a:xfrm>
            <a:off x="6134014" y="831668"/>
            <a:ext cx="448384" cy="3300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(B)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7585251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3A8CC6B7-AD0E-2805-72DE-EDDA01D092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8472"/>
            <a:ext cx="12192000" cy="1824808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10E7AC34-69C0-E716-63C7-D91D1CBD551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474144"/>
            <a:ext cx="12192000" cy="1824808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4B913141-C065-F717-37D2-1E6DCBD931F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99096"/>
            <a:ext cx="12192000" cy="182480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68F3DC35-8B7E-AEC6-9C4A-2B727105EC36}"/>
              </a:ext>
            </a:extLst>
          </p:cNvPr>
          <p:cNvSpPr txBox="1"/>
          <p:nvPr/>
        </p:nvSpPr>
        <p:spPr>
          <a:xfrm>
            <a:off x="0" y="3777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F5576A2-87EA-254A-8743-585C27904A69}"/>
              </a:ext>
            </a:extLst>
          </p:cNvPr>
          <p:cNvSpPr txBox="1"/>
          <p:nvPr/>
        </p:nvSpPr>
        <p:spPr>
          <a:xfrm>
            <a:off x="0" y="222080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BE2EA1-5BE6-003A-EA94-6BAAF166DEBA}"/>
              </a:ext>
            </a:extLst>
          </p:cNvPr>
          <p:cNvSpPr txBox="1"/>
          <p:nvPr/>
        </p:nvSpPr>
        <p:spPr>
          <a:xfrm>
            <a:off x="0" y="4383856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(C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CFD3056-159B-78D9-ED57-CDF704662037}"/>
              </a:ext>
            </a:extLst>
          </p:cNvPr>
          <p:cNvSpPr txBox="1"/>
          <p:nvPr/>
        </p:nvSpPr>
        <p:spPr>
          <a:xfrm>
            <a:off x="144990" y="6399528"/>
            <a:ext cx="11902020" cy="6126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-NMR spectra of mouse serum sample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MR analysis of control (A), positive control (B) and administered with sulforaphane after second-hand smoke exposure group (C) in serum samples. </a:t>
            </a:r>
            <a:endParaRPr lang="ko-KR" alt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38063AF-C891-FCE9-63D2-D4CAE5BD5CFB}"/>
              </a:ext>
            </a:extLst>
          </p:cNvPr>
          <p:cNvSpPr txBox="1"/>
          <p:nvPr/>
        </p:nvSpPr>
        <p:spPr>
          <a:xfrm rot="10800000">
            <a:off x="9325848" y="-81280"/>
            <a:ext cx="369332" cy="15173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3-Hydroxybutyr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3F96B05E-D013-9E6C-26E2-3952E71DB5B0}"/>
              </a:ext>
            </a:extLst>
          </p:cNvPr>
          <p:cNvCxnSpPr>
            <a:cxnSpLocks/>
          </p:cNvCxnSpPr>
          <p:nvPr/>
        </p:nvCxnSpPr>
        <p:spPr>
          <a:xfrm flipV="1">
            <a:off x="9510514" y="148279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B627895-0AE2-421E-B7B8-06FD87F69BEF}"/>
              </a:ext>
            </a:extLst>
          </p:cNvPr>
          <p:cNvSpPr txBox="1"/>
          <p:nvPr/>
        </p:nvSpPr>
        <p:spPr>
          <a:xfrm rot="10800000">
            <a:off x="8358943" y="1162842"/>
            <a:ext cx="369332" cy="61279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Argin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7565E7E0-163B-496A-1803-12E7DE856779}"/>
              </a:ext>
            </a:extLst>
          </p:cNvPr>
          <p:cNvCxnSpPr>
            <a:cxnSpLocks/>
          </p:cNvCxnSpPr>
          <p:nvPr/>
        </p:nvCxnSpPr>
        <p:spPr>
          <a:xfrm flipV="1">
            <a:off x="8553769" y="178476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EEE59FF-9E58-E878-F7B0-A77548ECDC5F}"/>
              </a:ext>
            </a:extLst>
          </p:cNvPr>
          <p:cNvSpPr txBox="1"/>
          <p:nvPr/>
        </p:nvSpPr>
        <p:spPr>
          <a:xfrm rot="10800000">
            <a:off x="5901174" y="1007722"/>
            <a:ext cx="369332" cy="7848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Asparag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DEF25251-3BB7-5989-588B-EB763B78F902}"/>
              </a:ext>
            </a:extLst>
          </p:cNvPr>
          <p:cNvCxnSpPr>
            <a:cxnSpLocks/>
          </p:cNvCxnSpPr>
          <p:nvPr/>
        </p:nvCxnSpPr>
        <p:spPr>
          <a:xfrm flipV="1">
            <a:off x="6096000" y="1786816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0A9A7A3D-47AF-1E3C-0A0C-D071E4264F95}"/>
              </a:ext>
            </a:extLst>
          </p:cNvPr>
          <p:cNvSpPr txBox="1"/>
          <p:nvPr/>
        </p:nvSpPr>
        <p:spPr>
          <a:xfrm rot="10800000">
            <a:off x="3899738" y="997562"/>
            <a:ext cx="369332" cy="78489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Asparag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5A8159DC-B66C-1C8A-BC34-FB48026CF7CE}"/>
              </a:ext>
            </a:extLst>
          </p:cNvPr>
          <p:cNvCxnSpPr>
            <a:cxnSpLocks/>
          </p:cNvCxnSpPr>
          <p:nvPr/>
        </p:nvCxnSpPr>
        <p:spPr>
          <a:xfrm flipV="1">
            <a:off x="4094564" y="1776656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A8C0DF70-63A5-3F0D-A2CB-F8DC9E8700A5}"/>
              </a:ext>
            </a:extLst>
          </p:cNvPr>
          <p:cNvSpPr txBox="1"/>
          <p:nvPr/>
        </p:nvSpPr>
        <p:spPr>
          <a:xfrm rot="10800000">
            <a:off x="6374824" y="1174442"/>
            <a:ext cx="369332" cy="5636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Citr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0AD75E05-A6FD-00C5-3BB7-45915B14361D}"/>
              </a:ext>
            </a:extLst>
          </p:cNvPr>
          <p:cNvCxnSpPr>
            <a:cxnSpLocks/>
          </p:cNvCxnSpPr>
          <p:nvPr/>
        </p:nvCxnSpPr>
        <p:spPr>
          <a:xfrm flipV="1">
            <a:off x="6559490" y="178476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ED2428DC-6BA7-C486-5135-4F1838F156F3}"/>
              </a:ext>
            </a:extLst>
          </p:cNvPr>
          <p:cNvSpPr txBox="1"/>
          <p:nvPr/>
        </p:nvSpPr>
        <p:spPr>
          <a:xfrm rot="10800000">
            <a:off x="5681213" y="967082"/>
            <a:ext cx="369332" cy="79505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Creat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064F81DB-57E2-F53A-8EDD-92D1F6B4ED05}"/>
              </a:ext>
            </a:extLst>
          </p:cNvPr>
          <p:cNvCxnSpPr>
            <a:cxnSpLocks/>
          </p:cNvCxnSpPr>
          <p:nvPr/>
        </p:nvCxnSpPr>
        <p:spPr>
          <a:xfrm flipV="1">
            <a:off x="5876039" y="1737726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56A98C0-3FE7-4B10-F05A-29693A6B3450}"/>
              </a:ext>
            </a:extLst>
          </p:cNvPr>
          <p:cNvSpPr txBox="1"/>
          <p:nvPr/>
        </p:nvSpPr>
        <p:spPr>
          <a:xfrm rot="10800000">
            <a:off x="1319768" y="971247"/>
            <a:ext cx="369332" cy="589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cos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E7731648-6E0D-6681-BA67-D1EA030C0930}"/>
              </a:ext>
            </a:extLst>
          </p:cNvPr>
          <p:cNvCxnSpPr>
            <a:cxnSpLocks/>
          </p:cNvCxnSpPr>
          <p:nvPr/>
        </p:nvCxnSpPr>
        <p:spPr>
          <a:xfrm flipV="1">
            <a:off x="1514594" y="155391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FB01000B-3D4F-7580-7EAD-A3CEC51410FE}"/>
              </a:ext>
            </a:extLst>
          </p:cNvPr>
          <p:cNvSpPr txBox="1"/>
          <p:nvPr/>
        </p:nvSpPr>
        <p:spPr>
          <a:xfrm rot="10800000">
            <a:off x="2496820" y="971247"/>
            <a:ext cx="369332" cy="589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cos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F8D776F0-C5F3-69B9-2FF4-101D6FB60F88}"/>
              </a:ext>
            </a:extLst>
          </p:cNvPr>
          <p:cNvCxnSpPr>
            <a:cxnSpLocks/>
          </p:cNvCxnSpPr>
          <p:nvPr/>
        </p:nvCxnSpPr>
        <p:spPr>
          <a:xfrm flipV="1">
            <a:off x="2691646" y="155391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9135982D-7ECC-33EF-B99D-4559438C67DF}"/>
              </a:ext>
            </a:extLst>
          </p:cNvPr>
          <p:cNvSpPr txBox="1"/>
          <p:nvPr/>
        </p:nvSpPr>
        <p:spPr>
          <a:xfrm rot="10800000">
            <a:off x="4309335" y="971247"/>
            <a:ext cx="369332" cy="589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cos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248E9DCA-CCA4-BDA6-21DF-9BD1A4470BB7}"/>
              </a:ext>
            </a:extLst>
          </p:cNvPr>
          <p:cNvCxnSpPr>
            <a:cxnSpLocks/>
          </p:cNvCxnSpPr>
          <p:nvPr/>
        </p:nvCxnSpPr>
        <p:spPr>
          <a:xfrm flipV="1">
            <a:off x="4504161" y="155391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9845EF9C-06B3-2F9F-C0CB-83450FC81A1B}"/>
              </a:ext>
            </a:extLst>
          </p:cNvPr>
          <p:cNvSpPr txBox="1"/>
          <p:nvPr/>
        </p:nvSpPr>
        <p:spPr>
          <a:xfrm rot="10800000">
            <a:off x="4800448" y="666447"/>
            <a:ext cx="369332" cy="589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cos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1A1C7C4F-BD5F-0E68-B6F7-A8269A47E0B4}"/>
              </a:ext>
            </a:extLst>
          </p:cNvPr>
          <p:cNvCxnSpPr>
            <a:cxnSpLocks/>
          </p:cNvCxnSpPr>
          <p:nvPr/>
        </p:nvCxnSpPr>
        <p:spPr>
          <a:xfrm flipV="1">
            <a:off x="4995274" y="1249117"/>
            <a:ext cx="0" cy="39878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138EECC3-EEA8-9D01-CFB5-6EBEB214C3A5}"/>
              </a:ext>
            </a:extLst>
          </p:cNvPr>
          <p:cNvSpPr txBox="1"/>
          <p:nvPr/>
        </p:nvSpPr>
        <p:spPr>
          <a:xfrm rot="10800000">
            <a:off x="5287724" y="798527"/>
            <a:ext cx="369332" cy="589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cos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8892491E-1938-9A0E-CE1F-734D2475F592}"/>
              </a:ext>
            </a:extLst>
          </p:cNvPr>
          <p:cNvCxnSpPr>
            <a:cxnSpLocks/>
          </p:cNvCxnSpPr>
          <p:nvPr/>
        </p:nvCxnSpPr>
        <p:spPr>
          <a:xfrm flipV="1">
            <a:off x="5482550" y="138119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49F925B8-5010-C17E-35BC-ABE32022934B}"/>
              </a:ext>
            </a:extLst>
          </p:cNvPr>
          <p:cNvSpPr txBox="1"/>
          <p:nvPr/>
        </p:nvSpPr>
        <p:spPr>
          <a:xfrm rot="10800000">
            <a:off x="7480666" y="582930"/>
            <a:ext cx="369332" cy="110808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tam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91C677B7-476D-24BA-905F-C5A6D06F30BC}"/>
              </a:ext>
            </a:extLst>
          </p:cNvPr>
          <p:cNvCxnSpPr>
            <a:cxnSpLocks/>
          </p:cNvCxnSpPr>
          <p:nvPr/>
        </p:nvCxnSpPr>
        <p:spPr>
          <a:xfrm flipV="1">
            <a:off x="7665332" y="1737726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DE19754A-0F6A-F1AE-6AEF-478C8BE054EB}"/>
              </a:ext>
            </a:extLst>
          </p:cNvPr>
          <p:cNvSpPr txBox="1"/>
          <p:nvPr/>
        </p:nvSpPr>
        <p:spPr>
          <a:xfrm rot="10800000">
            <a:off x="6845081" y="616893"/>
            <a:ext cx="369332" cy="110808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tam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D6F44FC2-6B1A-9491-0733-5482BD3F9B91}"/>
              </a:ext>
            </a:extLst>
          </p:cNvPr>
          <p:cNvCxnSpPr>
            <a:cxnSpLocks/>
          </p:cNvCxnSpPr>
          <p:nvPr/>
        </p:nvCxnSpPr>
        <p:spPr>
          <a:xfrm flipV="1">
            <a:off x="7029747" y="1771689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14138A8B-3FAC-234C-EC9B-3C58D012B410}"/>
              </a:ext>
            </a:extLst>
          </p:cNvPr>
          <p:cNvSpPr txBox="1"/>
          <p:nvPr/>
        </p:nvSpPr>
        <p:spPr>
          <a:xfrm rot="10800000">
            <a:off x="4482826" y="872471"/>
            <a:ext cx="369332" cy="84295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>
                <a:latin typeface="Calibri" panose="020F0502020204030204" pitchFamily="34" charset="0"/>
                <a:cs typeface="Calibri" panose="020F0502020204030204" pitchFamily="34" charset="0"/>
              </a:rPr>
              <a:t>Glycerol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998B7D4C-6862-96B9-2486-0EAB786831E3}"/>
              </a:ext>
            </a:extLst>
          </p:cNvPr>
          <p:cNvCxnSpPr>
            <a:cxnSpLocks/>
          </p:cNvCxnSpPr>
          <p:nvPr/>
        </p:nvCxnSpPr>
        <p:spPr>
          <a:xfrm flipV="1">
            <a:off x="4667492" y="176213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5DC8F22D-259F-6428-2528-4824C1F3711E}"/>
              </a:ext>
            </a:extLst>
          </p:cNvPr>
          <p:cNvSpPr txBox="1"/>
          <p:nvPr/>
        </p:nvSpPr>
        <p:spPr>
          <a:xfrm rot="10800000">
            <a:off x="3536168" y="915736"/>
            <a:ext cx="369332" cy="54425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Lact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3459210A-92AC-55AE-EBAE-591370051BC3}"/>
              </a:ext>
            </a:extLst>
          </p:cNvPr>
          <p:cNvCxnSpPr>
            <a:cxnSpLocks/>
          </p:cNvCxnSpPr>
          <p:nvPr/>
        </p:nvCxnSpPr>
        <p:spPr>
          <a:xfrm flipV="1">
            <a:off x="3737506" y="1463474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9145BD5F-7573-1783-C4F4-67452D5DD185}"/>
              </a:ext>
            </a:extLst>
          </p:cNvPr>
          <p:cNvSpPr txBox="1"/>
          <p:nvPr/>
        </p:nvSpPr>
        <p:spPr>
          <a:xfrm rot="10800000">
            <a:off x="9088008" y="-188680"/>
            <a:ext cx="369332" cy="56224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Lact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1D4C28E6-AA4D-C971-93D9-7B8E7FDFA77B}"/>
              </a:ext>
            </a:extLst>
          </p:cNvPr>
          <p:cNvCxnSpPr>
            <a:cxnSpLocks/>
          </p:cNvCxnSpPr>
          <p:nvPr/>
        </p:nvCxnSpPr>
        <p:spPr>
          <a:xfrm flipV="1">
            <a:off x="9272674" y="407102"/>
            <a:ext cx="0" cy="12720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C8329A5E-19C3-1728-BEB1-B02320CAD9AB}"/>
              </a:ext>
            </a:extLst>
          </p:cNvPr>
          <p:cNvSpPr txBox="1"/>
          <p:nvPr/>
        </p:nvSpPr>
        <p:spPr>
          <a:xfrm rot="10800000">
            <a:off x="9761781" y="798526"/>
            <a:ext cx="369332" cy="90426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>
                <a:latin typeface="Calibri" panose="020F0502020204030204" pitchFamily="34" charset="0"/>
                <a:cs typeface="Calibri" panose="020F0502020204030204" pitchFamily="34" charset="0"/>
              </a:rPr>
              <a:t>Leuc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BB8DB9DC-11B9-78FD-9949-82742DAB3BC1}"/>
              </a:ext>
            </a:extLst>
          </p:cNvPr>
          <p:cNvCxnSpPr>
            <a:cxnSpLocks/>
          </p:cNvCxnSpPr>
          <p:nvPr/>
        </p:nvCxnSpPr>
        <p:spPr>
          <a:xfrm flipV="1">
            <a:off x="9946447" y="174949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A43B443A-2024-6064-4B21-DFF1D3A8F220}"/>
              </a:ext>
            </a:extLst>
          </p:cNvPr>
          <p:cNvSpPr txBox="1"/>
          <p:nvPr/>
        </p:nvSpPr>
        <p:spPr>
          <a:xfrm rot="10800000">
            <a:off x="8892736" y="1178180"/>
            <a:ext cx="369332" cy="5636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Lys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A57501F4-A088-C464-9E63-0F15BBD5B1D9}"/>
              </a:ext>
            </a:extLst>
          </p:cNvPr>
          <p:cNvCxnSpPr>
            <a:cxnSpLocks/>
          </p:cNvCxnSpPr>
          <p:nvPr/>
        </p:nvCxnSpPr>
        <p:spPr>
          <a:xfrm flipV="1">
            <a:off x="9107882" y="1788505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17DBF3BA-FD18-23BA-3421-69CBC28DB460}"/>
              </a:ext>
            </a:extLst>
          </p:cNvPr>
          <p:cNvSpPr txBox="1"/>
          <p:nvPr/>
        </p:nvSpPr>
        <p:spPr>
          <a:xfrm rot="10800000">
            <a:off x="7934320" y="896620"/>
            <a:ext cx="369332" cy="84977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>
                <a:latin typeface="Calibri" panose="020F0502020204030204" pitchFamily="34" charset="0"/>
                <a:cs typeface="Calibri" panose="020F0502020204030204" pitchFamily="34" charset="0"/>
              </a:rPr>
              <a:t>Ornith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7F7E6315-CF68-5529-348E-03E855E1A488}"/>
              </a:ext>
            </a:extLst>
          </p:cNvPr>
          <p:cNvCxnSpPr>
            <a:cxnSpLocks/>
          </p:cNvCxnSpPr>
          <p:nvPr/>
        </p:nvCxnSpPr>
        <p:spPr>
          <a:xfrm flipV="1">
            <a:off x="8118986" y="1793103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9935C1D8-90FA-47F8-B1EC-AF00F0359ABD}"/>
              </a:ext>
            </a:extLst>
          </p:cNvPr>
          <p:cNvSpPr txBox="1"/>
          <p:nvPr/>
        </p:nvSpPr>
        <p:spPr>
          <a:xfrm rot="10800000">
            <a:off x="7011729" y="-32582"/>
            <a:ext cx="369332" cy="110808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Pyruv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46D7121A-62D1-C603-597E-A6EBC7FB69E1}"/>
              </a:ext>
            </a:extLst>
          </p:cNvPr>
          <p:cNvCxnSpPr>
            <a:cxnSpLocks/>
          </p:cNvCxnSpPr>
          <p:nvPr/>
        </p:nvCxnSpPr>
        <p:spPr>
          <a:xfrm flipV="1">
            <a:off x="7196395" y="1122214"/>
            <a:ext cx="0" cy="83358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4BFFFFDF-F508-473A-A5C5-6051C0FEB931}"/>
              </a:ext>
            </a:extLst>
          </p:cNvPr>
          <p:cNvSpPr txBox="1"/>
          <p:nvPr/>
        </p:nvSpPr>
        <p:spPr>
          <a:xfrm rot="10800000">
            <a:off x="3837091" y="445993"/>
            <a:ext cx="369332" cy="5636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er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AE9BA88E-232F-D81C-1BBE-3763DB591550}"/>
              </a:ext>
            </a:extLst>
          </p:cNvPr>
          <p:cNvCxnSpPr>
            <a:cxnSpLocks/>
          </p:cNvCxnSpPr>
          <p:nvPr/>
        </p:nvCxnSpPr>
        <p:spPr>
          <a:xfrm flipV="1">
            <a:off x="4014191" y="1056318"/>
            <a:ext cx="7566" cy="97251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09B5AA1F-54D2-34E8-E733-E976D01F7C56}"/>
              </a:ext>
            </a:extLst>
          </p:cNvPr>
          <p:cNvSpPr txBox="1"/>
          <p:nvPr/>
        </p:nvSpPr>
        <p:spPr>
          <a:xfrm rot="10800000">
            <a:off x="5230591" y="127370"/>
            <a:ext cx="369332" cy="55476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Taur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666FCD46-B984-B0FD-2BFC-0F5BD92CDBCE}"/>
              </a:ext>
            </a:extLst>
          </p:cNvPr>
          <p:cNvCxnSpPr>
            <a:cxnSpLocks/>
            <a:endCxn id="62" idx="0"/>
          </p:cNvCxnSpPr>
          <p:nvPr/>
        </p:nvCxnSpPr>
        <p:spPr>
          <a:xfrm flipH="1" flipV="1">
            <a:off x="5415257" y="682137"/>
            <a:ext cx="2891" cy="106324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308736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 descr="안테나이(가) 표시된 사진&#10;&#10;자동 생성된 설명">
            <a:extLst>
              <a:ext uri="{FF2B5EF4-FFF2-40B4-BE49-F238E27FC236}">
                <a16:creationId xmlns:a16="http://schemas.microsoft.com/office/drawing/2014/main" id="{89F8D4A4-C3CB-242F-1968-F26E430380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28408"/>
            <a:ext cx="12192000" cy="1842676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30F90580-818A-231B-078E-3F0A2A799B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18396"/>
            <a:ext cx="12192000" cy="1842676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6548310A-DD12-6C57-72F6-FA9EA9162B9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6745"/>
            <a:ext cx="12192000" cy="184267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68F3DC35-8B7E-AEC6-9C4A-2B727105EC36}"/>
              </a:ext>
            </a:extLst>
          </p:cNvPr>
          <p:cNvSpPr txBox="1"/>
          <p:nvPr/>
        </p:nvSpPr>
        <p:spPr>
          <a:xfrm>
            <a:off x="0" y="3777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F5576A2-87EA-254A-8743-585C27904A69}"/>
              </a:ext>
            </a:extLst>
          </p:cNvPr>
          <p:cNvSpPr txBox="1"/>
          <p:nvPr/>
        </p:nvSpPr>
        <p:spPr>
          <a:xfrm>
            <a:off x="0" y="222080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BE2EA1-5BE6-003A-EA94-6BAAF166DEBA}"/>
              </a:ext>
            </a:extLst>
          </p:cNvPr>
          <p:cNvSpPr txBox="1"/>
          <p:nvPr/>
        </p:nvSpPr>
        <p:spPr>
          <a:xfrm>
            <a:off x="0" y="4383856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Calibri" panose="020F0502020204030204" pitchFamily="34" charset="0"/>
                <a:cs typeface="Calibri" panose="020F0502020204030204" pitchFamily="34" charset="0"/>
              </a:rPr>
              <a:t>(C)</a:t>
            </a:r>
            <a:endParaRPr lang="ko-KR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CFD3056-159B-78D9-ED57-CDF704662037}"/>
              </a:ext>
            </a:extLst>
          </p:cNvPr>
          <p:cNvSpPr txBox="1"/>
          <p:nvPr/>
        </p:nvSpPr>
        <p:spPr>
          <a:xfrm>
            <a:off x="169591" y="6386720"/>
            <a:ext cx="11707881" cy="6126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-NMR spectra of mouse lung sample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MR analysis of control (A), positive control (B) and administered with sulforaphane after second-hand smoke exposure group (C) in serum samples. </a:t>
            </a:r>
            <a:endParaRPr lang="ko-KR" altLang="en-US" sz="1200" dirty="0"/>
          </a:p>
        </p:txBody>
      </p:sp>
      <p:cxnSp>
        <p:nvCxnSpPr>
          <p:cNvPr id="4" name="직선 연결선 3">
            <a:extLst>
              <a:ext uri="{FF2B5EF4-FFF2-40B4-BE49-F238E27FC236}">
                <a16:creationId xmlns:a16="http://schemas.microsoft.com/office/drawing/2014/main" id="{C0A25A74-14FF-0ED9-7E54-58E3B11822A0}"/>
              </a:ext>
            </a:extLst>
          </p:cNvPr>
          <p:cNvCxnSpPr>
            <a:cxnSpLocks/>
          </p:cNvCxnSpPr>
          <p:nvPr/>
        </p:nvCxnSpPr>
        <p:spPr>
          <a:xfrm flipV="1">
            <a:off x="8069580" y="1501140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E13E454-29ED-EF34-AF33-A78CD1D3CD96}"/>
              </a:ext>
            </a:extLst>
          </p:cNvPr>
          <p:cNvSpPr txBox="1"/>
          <p:nvPr/>
        </p:nvSpPr>
        <p:spPr>
          <a:xfrm rot="10800000">
            <a:off x="7884914" y="899596"/>
            <a:ext cx="369332" cy="57227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Acet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FFD201F-D84B-D752-C280-8547B6812487}"/>
              </a:ext>
            </a:extLst>
          </p:cNvPr>
          <p:cNvSpPr txBox="1"/>
          <p:nvPr/>
        </p:nvSpPr>
        <p:spPr>
          <a:xfrm rot="10800000">
            <a:off x="8758674" y="819695"/>
            <a:ext cx="369332" cy="56361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Alan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5BAC9C5D-AB7E-C379-9008-3EECE32FF573}"/>
              </a:ext>
            </a:extLst>
          </p:cNvPr>
          <p:cNvCxnSpPr>
            <a:cxnSpLocks/>
          </p:cNvCxnSpPr>
          <p:nvPr/>
        </p:nvCxnSpPr>
        <p:spPr>
          <a:xfrm flipV="1">
            <a:off x="8943340" y="1430020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4F0EE048-BF66-CCE6-634E-2C7AA36BC7D8}"/>
              </a:ext>
            </a:extLst>
          </p:cNvPr>
          <p:cNvSpPr txBox="1"/>
          <p:nvPr/>
        </p:nvSpPr>
        <p:spPr>
          <a:xfrm rot="10800000">
            <a:off x="8358943" y="919002"/>
            <a:ext cx="369332" cy="61279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Argin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2DCA29F8-6105-6014-E098-6C2DA7DC109E}"/>
              </a:ext>
            </a:extLst>
          </p:cNvPr>
          <p:cNvCxnSpPr>
            <a:cxnSpLocks/>
          </p:cNvCxnSpPr>
          <p:nvPr/>
        </p:nvCxnSpPr>
        <p:spPr>
          <a:xfrm flipV="1">
            <a:off x="8553769" y="154092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E3E30D48-458F-DD96-3AD6-8AB263D8DDD3}"/>
              </a:ext>
            </a:extLst>
          </p:cNvPr>
          <p:cNvSpPr txBox="1"/>
          <p:nvPr/>
        </p:nvSpPr>
        <p:spPr>
          <a:xfrm rot="10800000">
            <a:off x="6894791" y="854862"/>
            <a:ext cx="369332" cy="65979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Carnit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1F6533B8-4309-59D1-3A22-F4F1205EC3EC}"/>
              </a:ext>
            </a:extLst>
          </p:cNvPr>
          <p:cNvCxnSpPr>
            <a:cxnSpLocks/>
          </p:cNvCxnSpPr>
          <p:nvPr/>
        </p:nvCxnSpPr>
        <p:spPr>
          <a:xfrm flipV="1">
            <a:off x="7079457" y="151327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1115E930-DE9D-7DB8-3C08-3D9DBBD980AE}"/>
              </a:ext>
            </a:extLst>
          </p:cNvPr>
          <p:cNvSpPr txBox="1"/>
          <p:nvPr/>
        </p:nvSpPr>
        <p:spPr>
          <a:xfrm rot="10800000">
            <a:off x="5370514" y="151112"/>
            <a:ext cx="369332" cy="56361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Chol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6F59AAE4-3807-3A6E-4D32-00610289E067}"/>
              </a:ext>
            </a:extLst>
          </p:cNvPr>
          <p:cNvCxnSpPr>
            <a:cxnSpLocks/>
          </p:cNvCxnSpPr>
          <p:nvPr/>
        </p:nvCxnSpPr>
        <p:spPr>
          <a:xfrm flipV="1">
            <a:off x="5545020" y="762000"/>
            <a:ext cx="0" cy="16453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CDEC41C-69AE-9C07-6196-6CE13F4ED34C}"/>
              </a:ext>
            </a:extLst>
          </p:cNvPr>
          <p:cNvSpPr txBox="1"/>
          <p:nvPr/>
        </p:nvSpPr>
        <p:spPr>
          <a:xfrm rot="10800000">
            <a:off x="5670037" y="733590"/>
            <a:ext cx="369332" cy="61786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Creat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EE4A5983-DA12-8D52-1338-2777BB6E2CD4}"/>
              </a:ext>
            </a:extLst>
          </p:cNvPr>
          <p:cNvCxnSpPr>
            <a:cxnSpLocks/>
          </p:cNvCxnSpPr>
          <p:nvPr/>
        </p:nvCxnSpPr>
        <p:spPr>
          <a:xfrm flipV="1">
            <a:off x="5864863" y="138119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90C012F2-039E-600C-9053-5EEC47EBEFF5}"/>
              </a:ext>
            </a:extLst>
          </p:cNvPr>
          <p:cNvSpPr txBox="1"/>
          <p:nvPr/>
        </p:nvSpPr>
        <p:spPr>
          <a:xfrm rot="10800000">
            <a:off x="5479534" y="594271"/>
            <a:ext cx="369332" cy="95776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Ethanolam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0D6365EB-0E46-6A4C-E994-2CF3A570ABBD}"/>
              </a:ext>
            </a:extLst>
          </p:cNvPr>
          <p:cNvCxnSpPr>
            <a:cxnSpLocks/>
          </p:cNvCxnSpPr>
          <p:nvPr/>
        </p:nvCxnSpPr>
        <p:spPr>
          <a:xfrm flipV="1">
            <a:off x="5654040" y="1523585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6F02315A-68FD-388B-CC22-3B9F1EB1EF46}"/>
              </a:ext>
            </a:extLst>
          </p:cNvPr>
          <p:cNvSpPr txBox="1"/>
          <p:nvPr/>
        </p:nvSpPr>
        <p:spPr>
          <a:xfrm rot="10800000">
            <a:off x="1319768" y="950927"/>
            <a:ext cx="369332" cy="589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cos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072EA89C-25CA-9926-A08B-E48012D19757}"/>
              </a:ext>
            </a:extLst>
          </p:cNvPr>
          <p:cNvCxnSpPr>
            <a:cxnSpLocks/>
          </p:cNvCxnSpPr>
          <p:nvPr/>
        </p:nvCxnSpPr>
        <p:spPr>
          <a:xfrm flipV="1">
            <a:off x="1514594" y="153359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003AF593-A2CF-7C19-EADF-41663003A4A8}"/>
              </a:ext>
            </a:extLst>
          </p:cNvPr>
          <p:cNvCxnSpPr>
            <a:cxnSpLocks/>
          </p:cNvCxnSpPr>
          <p:nvPr/>
        </p:nvCxnSpPr>
        <p:spPr>
          <a:xfrm flipV="1">
            <a:off x="7211856" y="1065462"/>
            <a:ext cx="0" cy="66371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CEE047CF-391A-1032-F45D-4B7F6E23AF83}"/>
              </a:ext>
            </a:extLst>
          </p:cNvPr>
          <p:cNvSpPr txBox="1"/>
          <p:nvPr/>
        </p:nvSpPr>
        <p:spPr>
          <a:xfrm rot="10800000">
            <a:off x="7017030" y="313576"/>
            <a:ext cx="369332" cy="75103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tam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5EBE9E5-7FB9-25FD-593C-E105FE1EA5E5}"/>
              </a:ext>
            </a:extLst>
          </p:cNvPr>
          <p:cNvSpPr txBox="1"/>
          <p:nvPr/>
        </p:nvSpPr>
        <p:spPr>
          <a:xfrm rot="10800000">
            <a:off x="4390253" y="800267"/>
            <a:ext cx="369332" cy="60247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ycerol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5E3617CC-598D-1FF1-2793-204D08C3D69D}"/>
              </a:ext>
            </a:extLst>
          </p:cNvPr>
          <p:cNvCxnSpPr>
            <a:cxnSpLocks/>
          </p:cNvCxnSpPr>
          <p:nvPr/>
        </p:nvCxnSpPr>
        <p:spPr>
          <a:xfrm flipV="1">
            <a:off x="4595239" y="1430020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0FDB47C6-4BAF-4EC2-888F-22B8B032813A}"/>
              </a:ext>
            </a:extLst>
          </p:cNvPr>
          <p:cNvSpPr txBox="1"/>
          <p:nvPr/>
        </p:nvSpPr>
        <p:spPr>
          <a:xfrm rot="10800000">
            <a:off x="4636491" y="46746"/>
            <a:ext cx="369332" cy="55047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yc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19E6D8AD-682A-1615-BE94-AC02C3E6F49F}"/>
              </a:ext>
            </a:extLst>
          </p:cNvPr>
          <p:cNvCxnSpPr>
            <a:cxnSpLocks/>
          </p:cNvCxnSpPr>
          <p:nvPr/>
        </p:nvCxnSpPr>
        <p:spPr>
          <a:xfrm flipV="1">
            <a:off x="4829902" y="594270"/>
            <a:ext cx="0" cy="1724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794B2FBB-4D1D-4C62-BE53-1DBE0646F52F}"/>
              </a:ext>
            </a:extLst>
          </p:cNvPr>
          <p:cNvSpPr txBox="1"/>
          <p:nvPr/>
        </p:nvSpPr>
        <p:spPr>
          <a:xfrm rot="10800000">
            <a:off x="9038319" y="245353"/>
            <a:ext cx="369332" cy="5636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Lact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7945CEA1-CC2C-FA54-916B-566A9AA7563F}"/>
              </a:ext>
            </a:extLst>
          </p:cNvPr>
          <p:cNvCxnSpPr>
            <a:cxnSpLocks/>
          </p:cNvCxnSpPr>
          <p:nvPr/>
        </p:nvCxnSpPr>
        <p:spPr>
          <a:xfrm flipV="1">
            <a:off x="9222985" y="855678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77A9DB2C-A9D9-8528-FC37-BC8EAA6E4E34}"/>
              </a:ext>
            </a:extLst>
          </p:cNvPr>
          <p:cNvSpPr txBox="1"/>
          <p:nvPr/>
        </p:nvSpPr>
        <p:spPr>
          <a:xfrm rot="10800000">
            <a:off x="3549477" y="885074"/>
            <a:ext cx="369332" cy="5636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Lactat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17A7B6F8-0174-008E-D749-8592FCF3F50E}"/>
              </a:ext>
            </a:extLst>
          </p:cNvPr>
          <p:cNvCxnSpPr>
            <a:cxnSpLocks/>
          </p:cNvCxnSpPr>
          <p:nvPr/>
        </p:nvCxnSpPr>
        <p:spPr>
          <a:xfrm flipV="1">
            <a:off x="3734143" y="1460674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7FDE1FD9-FA96-0F74-B04E-33174EAD05BB}"/>
              </a:ext>
            </a:extLst>
          </p:cNvPr>
          <p:cNvSpPr txBox="1"/>
          <p:nvPr/>
        </p:nvSpPr>
        <p:spPr>
          <a:xfrm rot="10800000">
            <a:off x="9766717" y="533216"/>
            <a:ext cx="369332" cy="94917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Leuc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1B00B0CE-FE3E-08D9-3D68-5E4F9EBA9C67}"/>
              </a:ext>
            </a:extLst>
          </p:cNvPr>
          <p:cNvCxnSpPr>
            <a:cxnSpLocks/>
          </p:cNvCxnSpPr>
          <p:nvPr/>
        </p:nvCxnSpPr>
        <p:spPr>
          <a:xfrm flipV="1">
            <a:off x="9974533" y="150594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2AA8C507-3F0A-0314-26C6-0B38E115F0CE}"/>
              </a:ext>
            </a:extLst>
          </p:cNvPr>
          <p:cNvSpPr txBox="1"/>
          <p:nvPr/>
        </p:nvSpPr>
        <p:spPr>
          <a:xfrm rot="10800000">
            <a:off x="3866542" y="872472"/>
            <a:ext cx="369332" cy="5636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er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3A3260BD-D06D-8424-E911-475DA70B4560}"/>
              </a:ext>
            </a:extLst>
          </p:cNvPr>
          <p:cNvCxnSpPr>
            <a:cxnSpLocks/>
          </p:cNvCxnSpPr>
          <p:nvPr/>
        </p:nvCxnSpPr>
        <p:spPr>
          <a:xfrm flipV="1">
            <a:off x="4051208" y="148279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91D65379-843E-4E9E-7CBA-856A6B017224}"/>
              </a:ext>
            </a:extLst>
          </p:cNvPr>
          <p:cNvSpPr txBox="1"/>
          <p:nvPr/>
        </p:nvSpPr>
        <p:spPr>
          <a:xfrm rot="10800000">
            <a:off x="4949807" y="108545"/>
            <a:ext cx="369332" cy="56361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Taur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D87271F1-69C2-AE6A-98CF-6ADD93D92565}"/>
              </a:ext>
            </a:extLst>
          </p:cNvPr>
          <p:cNvCxnSpPr>
            <a:cxnSpLocks/>
          </p:cNvCxnSpPr>
          <p:nvPr/>
        </p:nvCxnSpPr>
        <p:spPr>
          <a:xfrm flipV="1">
            <a:off x="5103993" y="672161"/>
            <a:ext cx="0" cy="2555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09D3F4F8-485B-1929-9C04-D41417ADC6FC}"/>
              </a:ext>
            </a:extLst>
          </p:cNvPr>
          <p:cNvCxnSpPr>
            <a:cxnSpLocks/>
          </p:cNvCxnSpPr>
          <p:nvPr/>
        </p:nvCxnSpPr>
        <p:spPr>
          <a:xfrm flipH="1" flipV="1">
            <a:off x="5227320" y="626441"/>
            <a:ext cx="174844" cy="25553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FB09A8C6-C853-8880-F7C7-7B17753D8AA5}"/>
              </a:ext>
            </a:extLst>
          </p:cNvPr>
          <p:cNvSpPr txBox="1"/>
          <p:nvPr/>
        </p:nvSpPr>
        <p:spPr>
          <a:xfrm rot="10800000">
            <a:off x="3237926" y="533216"/>
            <a:ext cx="369332" cy="95367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Threonin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231F1784-9C24-0CF7-C41F-E22F97F7E6AF}"/>
              </a:ext>
            </a:extLst>
          </p:cNvPr>
          <p:cNvCxnSpPr>
            <a:cxnSpLocks/>
          </p:cNvCxnSpPr>
          <p:nvPr/>
        </p:nvCxnSpPr>
        <p:spPr>
          <a:xfrm flipV="1">
            <a:off x="3422592" y="153359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4A46BCCE-9C50-9F1E-B558-83DE18AD01B3}"/>
              </a:ext>
            </a:extLst>
          </p:cNvPr>
          <p:cNvSpPr txBox="1"/>
          <p:nvPr/>
        </p:nvSpPr>
        <p:spPr>
          <a:xfrm rot="10800000">
            <a:off x="2496820" y="971247"/>
            <a:ext cx="369332" cy="589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Glucose</a:t>
            </a:r>
            <a:endParaRPr lang="ko-KR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F546EB7B-4A8E-613B-8E04-8366B7D89395}"/>
              </a:ext>
            </a:extLst>
          </p:cNvPr>
          <p:cNvCxnSpPr>
            <a:cxnSpLocks/>
          </p:cNvCxnSpPr>
          <p:nvPr/>
        </p:nvCxnSpPr>
        <p:spPr>
          <a:xfrm flipV="1">
            <a:off x="2691646" y="1553917"/>
            <a:ext cx="0" cy="2667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317561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55</Words>
  <Application>Microsoft Office PowerPoint</Application>
  <PresentationFormat>와이드스크린</PresentationFormat>
  <Paragraphs>55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맑은 고딕</vt:lpstr>
      <vt:lpstr>Arial</vt:lpstr>
      <vt:lpstr>Calibri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Hongyoon</dc:creator>
  <cp:lastModifiedBy>김규봉</cp:lastModifiedBy>
  <cp:revision>4</cp:revision>
  <dcterms:created xsi:type="dcterms:W3CDTF">2022-04-11T09:05:04Z</dcterms:created>
  <dcterms:modified xsi:type="dcterms:W3CDTF">2022-05-27T14:57:04Z</dcterms:modified>
</cp:coreProperties>
</file>